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46" y="258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1142992\Dropbox\Research\Bats\Meis2\Illing%20Meis%20RACE%20analysis%20April%202014\Summary%20of%20lncMeis2%20TSS%20statistics_histogra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Z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1 (2)'!$B$1</c:f>
              <c:strCache>
                <c:ptCount val="1"/>
                <c:pt idx="0">
                  <c:v>Human ESTs</c:v>
                </c:pt>
              </c:strCache>
            </c:strRef>
          </c:tx>
          <c:invertIfNegative val="0"/>
          <c:cat>
            <c:strRef>
              <c:f>'Sheet1 (2)'!$A$2:$A$34</c:f>
              <c:strCache>
                <c:ptCount val="33"/>
                <c:pt idx="0">
                  <c:v>37392604-00</c:v>
                </c:pt>
                <c:pt idx="1">
                  <c:v>37392609-05</c:v>
                </c:pt>
                <c:pt idx="2">
                  <c:v>37392614-10</c:v>
                </c:pt>
                <c:pt idx="3">
                  <c:v>37392619-15</c:v>
                </c:pt>
                <c:pt idx="4">
                  <c:v>37392624-20</c:v>
                </c:pt>
                <c:pt idx="5">
                  <c:v>37392629-25</c:v>
                </c:pt>
                <c:pt idx="6">
                  <c:v>37392634-30</c:v>
                </c:pt>
                <c:pt idx="7">
                  <c:v>37392639-35</c:v>
                </c:pt>
                <c:pt idx="8">
                  <c:v>37392644-40</c:v>
                </c:pt>
                <c:pt idx="9">
                  <c:v>37392649-45</c:v>
                </c:pt>
                <c:pt idx="10">
                  <c:v>37392654-50</c:v>
                </c:pt>
                <c:pt idx="11">
                  <c:v>37392659-55</c:v>
                </c:pt>
                <c:pt idx="12">
                  <c:v>37392664-60</c:v>
                </c:pt>
                <c:pt idx="13">
                  <c:v>37392669-65</c:v>
                </c:pt>
                <c:pt idx="14">
                  <c:v>37392674-70</c:v>
                </c:pt>
                <c:pt idx="15">
                  <c:v>37392679-75</c:v>
                </c:pt>
                <c:pt idx="16">
                  <c:v>37392684-80</c:v>
                </c:pt>
                <c:pt idx="17">
                  <c:v>37392689-85</c:v>
                </c:pt>
                <c:pt idx="18">
                  <c:v>37392695-90</c:v>
                </c:pt>
                <c:pt idx="19">
                  <c:v>37392699-95</c:v>
                </c:pt>
                <c:pt idx="20">
                  <c:v>37392704-00</c:v>
                </c:pt>
                <c:pt idx="21">
                  <c:v>37392709-05</c:v>
                </c:pt>
                <c:pt idx="22">
                  <c:v>37392714-10</c:v>
                </c:pt>
                <c:pt idx="23">
                  <c:v>37392719-15</c:v>
                </c:pt>
                <c:pt idx="24">
                  <c:v>37392724-20</c:v>
                </c:pt>
                <c:pt idx="25">
                  <c:v>37392729-25</c:v>
                </c:pt>
                <c:pt idx="26">
                  <c:v>37392734-30</c:v>
                </c:pt>
                <c:pt idx="27">
                  <c:v>37392739-35</c:v>
                </c:pt>
                <c:pt idx="28">
                  <c:v>37392744-40</c:v>
                </c:pt>
                <c:pt idx="29">
                  <c:v>37392749-45</c:v>
                </c:pt>
                <c:pt idx="30">
                  <c:v>37392754-50</c:v>
                </c:pt>
                <c:pt idx="31">
                  <c:v>37392759-55</c:v>
                </c:pt>
                <c:pt idx="32">
                  <c:v>37392764-60</c:v>
                </c:pt>
              </c:strCache>
            </c:strRef>
          </c:cat>
          <c:val>
            <c:numRef>
              <c:f>'Sheet1 (2)'!$B$2:$B$34</c:f>
              <c:numCache>
                <c:formatCode>General</c:formatCode>
                <c:ptCount val="33"/>
                <c:pt idx="21">
                  <c:v>1</c:v>
                </c:pt>
                <c:pt idx="27">
                  <c:v>2</c:v>
                </c:pt>
                <c:pt idx="28">
                  <c:v>6</c:v>
                </c:pt>
                <c:pt idx="29">
                  <c:v>15</c:v>
                </c:pt>
                <c:pt idx="30">
                  <c:v>10</c:v>
                </c:pt>
              </c:numCache>
            </c:numRef>
          </c:val>
        </c:ser>
        <c:ser>
          <c:idx val="1"/>
          <c:order val="1"/>
          <c:tx>
            <c:strRef>
              <c:f>'Sheet1 (2)'!$C$1</c:f>
              <c:strCache>
                <c:ptCount val="1"/>
                <c:pt idx="0">
                  <c:v>Mouse ESTs</c:v>
                </c:pt>
              </c:strCache>
            </c:strRef>
          </c:tx>
          <c:spPr>
            <a:ln w="19050"/>
          </c:spPr>
          <c:invertIfNegative val="0"/>
          <c:cat>
            <c:strRef>
              <c:f>'Sheet1 (2)'!$A$2:$A$34</c:f>
              <c:strCache>
                <c:ptCount val="33"/>
                <c:pt idx="0">
                  <c:v>37392604-00</c:v>
                </c:pt>
                <c:pt idx="1">
                  <c:v>37392609-05</c:v>
                </c:pt>
                <c:pt idx="2">
                  <c:v>37392614-10</c:v>
                </c:pt>
                <c:pt idx="3">
                  <c:v>37392619-15</c:v>
                </c:pt>
                <c:pt idx="4">
                  <c:v>37392624-20</c:v>
                </c:pt>
                <c:pt idx="5">
                  <c:v>37392629-25</c:v>
                </c:pt>
                <c:pt idx="6">
                  <c:v>37392634-30</c:v>
                </c:pt>
                <c:pt idx="7">
                  <c:v>37392639-35</c:v>
                </c:pt>
                <c:pt idx="8">
                  <c:v>37392644-40</c:v>
                </c:pt>
                <c:pt idx="9">
                  <c:v>37392649-45</c:v>
                </c:pt>
                <c:pt idx="10">
                  <c:v>37392654-50</c:v>
                </c:pt>
                <c:pt idx="11">
                  <c:v>37392659-55</c:v>
                </c:pt>
                <c:pt idx="12">
                  <c:v>37392664-60</c:v>
                </c:pt>
                <c:pt idx="13">
                  <c:v>37392669-65</c:v>
                </c:pt>
                <c:pt idx="14">
                  <c:v>37392674-70</c:v>
                </c:pt>
                <c:pt idx="15">
                  <c:v>37392679-75</c:v>
                </c:pt>
                <c:pt idx="16">
                  <c:v>37392684-80</c:v>
                </c:pt>
                <c:pt idx="17">
                  <c:v>37392689-85</c:v>
                </c:pt>
                <c:pt idx="18">
                  <c:v>37392695-90</c:v>
                </c:pt>
                <c:pt idx="19">
                  <c:v>37392699-95</c:v>
                </c:pt>
                <c:pt idx="20">
                  <c:v>37392704-00</c:v>
                </c:pt>
                <c:pt idx="21">
                  <c:v>37392709-05</c:v>
                </c:pt>
                <c:pt idx="22">
                  <c:v>37392714-10</c:v>
                </c:pt>
                <c:pt idx="23">
                  <c:v>37392719-15</c:v>
                </c:pt>
                <c:pt idx="24">
                  <c:v>37392724-20</c:v>
                </c:pt>
                <c:pt idx="25">
                  <c:v>37392729-25</c:v>
                </c:pt>
                <c:pt idx="26">
                  <c:v>37392734-30</c:v>
                </c:pt>
                <c:pt idx="27">
                  <c:v>37392739-35</c:v>
                </c:pt>
                <c:pt idx="28">
                  <c:v>37392744-40</c:v>
                </c:pt>
                <c:pt idx="29">
                  <c:v>37392749-45</c:v>
                </c:pt>
                <c:pt idx="30">
                  <c:v>37392754-50</c:v>
                </c:pt>
                <c:pt idx="31">
                  <c:v>37392759-55</c:v>
                </c:pt>
                <c:pt idx="32">
                  <c:v>37392764-60</c:v>
                </c:pt>
              </c:strCache>
            </c:strRef>
          </c:cat>
          <c:val>
            <c:numRef>
              <c:f>'Sheet1 (2)'!$C$2:$C$34</c:f>
              <c:numCache>
                <c:formatCode>General</c:formatCode>
                <c:ptCount val="33"/>
                <c:pt idx="0">
                  <c:v>1</c:v>
                </c:pt>
                <c:pt idx="6">
                  <c:v>1</c:v>
                </c:pt>
                <c:pt idx="17">
                  <c:v>2</c:v>
                </c:pt>
                <c:pt idx="26">
                  <c:v>2</c:v>
                </c:pt>
                <c:pt idx="27">
                  <c:v>1</c:v>
                </c:pt>
              </c:numCache>
            </c:numRef>
          </c:val>
        </c:ser>
        <c:ser>
          <c:idx val="2"/>
          <c:order val="2"/>
          <c:tx>
            <c:strRef>
              <c:f>'Sheet1 (2)'!$D$1</c:f>
              <c:strCache>
                <c:ptCount val="1"/>
                <c:pt idx="0">
                  <c:v>Mouse Limb 5' RACE</c:v>
                </c:pt>
              </c:strCache>
            </c:strRef>
          </c:tx>
          <c:spPr>
            <a:ln w="76200"/>
          </c:spPr>
          <c:invertIfNegative val="0"/>
          <c:cat>
            <c:strRef>
              <c:f>'Sheet1 (2)'!$A$2:$A$34</c:f>
              <c:strCache>
                <c:ptCount val="33"/>
                <c:pt idx="0">
                  <c:v>37392604-00</c:v>
                </c:pt>
                <c:pt idx="1">
                  <c:v>37392609-05</c:v>
                </c:pt>
                <c:pt idx="2">
                  <c:v>37392614-10</c:v>
                </c:pt>
                <c:pt idx="3">
                  <c:v>37392619-15</c:v>
                </c:pt>
                <c:pt idx="4">
                  <c:v>37392624-20</c:v>
                </c:pt>
                <c:pt idx="5">
                  <c:v>37392629-25</c:v>
                </c:pt>
                <c:pt idx="6">
                  <c:v>37392634-30</c:v>
                </c:pt>
                <c:pt idx="7">
                  <c:v>37392639-35</c:v>
                </c:pt>
                <c:pt idx="8">
                  <c:v>37392644-40</c:v>
                </c:pt>
                <c:pt idx="9">
                  <c:v>37392649-45</c:v>
                </c:pt>
                <c:pt idx="10">
                  <c:v>37392654-50</c:v>
                </c:pt>
                <c:pt idx="11">
                  <c:v>37392659-55</c:v>
                </c:pt>
                <c:pt idx="12">
                  <c:v>37392664-60</c:v>
                </c:pt>
                <c:pt idx="13">
                  <c:v>37392669-65</c:v>
                </c:pt>
                <c:pt idx="14">
                  <c:v>37392674-70</c:v>
                </c:pt>
                <c:pt idx="15">
                  <c:v>37392679-75</c:v>
                </c:pt>
                <c:pt idx="16">
                  <c:v>37392684-80</c:v>
                </c:pt>
                <c:pt idx="17">
                  <c:v>37392689-85</c:v>
                </c:pt>
                <c:pt idx="18">
                  <c:v>37392695-90</c:v>
                </c:pt>
                <c:pt idx="19">
                  <c:v>37392699-95</c:v>
                </c:pt>
                <c:pt idx="20">
                  <c:v>37392704-00</c:v>
                </c:pt>
                <c:pt idx="21">
                  <c:v>37392709-05</c:v>
                </c:pt>
                <c:pt idx="22">
                  <c:v>37392714-10</c:v>
                </c:pt>
                <c:pt idx="23">
                  <c:v>37392719-15</c:v>
                </c:pt>
                <c:pt idx="24">
                  <c:v>37392724-20</c:v>
                </c:pt>
                <c:pt idx="25">
                  <c:v>37392729-25</c:v>
                </c:pt>
                <c:pt idx="26">
                  <c:v>37392734-30</c:v>
                </c:pt>
                <c:pt idx="27">
                  <c:v>37392739-35</c:v>
                </c:pt>
                <c:pt idx="28">
                  <c:v>37392744-40</c:v>
                </c:pt>
                <c:pt idx="29">
                  <c:v>37392749-45</c:v>
                </c:pt>
                <c:pt idx="30">
                  <c:v>37392754-50</c:v>
                </c:pt>
                <c:pt idx="31">
                  <c:v>37392759-55</c:v>
                </c:pt>
                <c:pt idx="32">
                  <c:v>37392764-60</c:v>
                </c:pt>
              </c:strCache>
            </c:strRef>
          </c:cat>
          <c:val>
            <c:numRef>
              <c:f>'Sheet1 (2)'!$D$2:$D$34</c:f>
              <c:numCache>
                <c:formatCode>General</c:formatCode>
                <c:ptCount val="33"/>
                <c:pt idx="12">
                  <c:v>1</c:v>
                </c:pt>
                <c:pt idx="21">
                  <c:v>2</c:v>
                </c:pt>
                <c:pt idx="24">
                  <c:v>1</c:v>
                </c:pt>
                <c:pt idx="26">
                  <c:v>1</c:v>
                </c:pt>
                <c:pt idx="28">
                  <c:v>1</c:v>
                </c:pt>
                <c:pt idx="29">
                  <c:v>2</c:v>
                </c:pt>
              </c:numCache>
            </c:numRef>
          </c:val>
        </c:ser>
        <c:ser>
          <c:idx val="3"/>
          <c:order val="3"/>
          <c:tx>
            <c:strRef>
              <c:f>'Sheet1 (2)'!$E$1</c:f>
              <c:strCache>
                <c:ptCount val="1"/>
                <c:pt idx="0">
                  <c:v>Mouse Head 5' RACE</c:v>
                </c:pt>
              </c:strCache>
            </c:strRef>
          </c:tx>
          <c:spPr>
            <a:ln w="76200"/>
          </c:spPr>
          <c:invertIfNegative val="0"/>
          <c:cat>
            <c:strRef>
              <c:f>'Sheet1 (2)'!$A$2:$A$34</c:f>
              <c:strCache>
                <c:ptCount val="33"/>
                <c:pt idx="0">
                  <c:v>37392604-00</c:v>
                </c:pt>
                <c:pt idx="1">
                  <c:v>37392609-05</c:v>
                </c:pt>
                <c:pt idx="2">
                  <c:v>37392614-10</c:v>
                </c:pt>
                <c:pt idx="3">
                  <c:v>37392619-15</c:v>
                </c:pt>
                <c:pt idx="4">
                  <c:v>37392624-20</c:v>
                </c:pt>
                <c:pt idx="5">
                  <c:v>37392629-25</c:v>
                </c:pt>
                <c:pt idx="6">
                  <c:v>37392634-30</c:v>
                </c:pt>
                <c:pt idx="7">
                  <c:v>37392639-35</c:v>
                </c:pt>
                <c:pt idx="8">
                  <c:v>37392644-40</c:v>
                </c:pt>
                <c:pt idx="9">
                  <c:v>37392649-45</c:v>
                </c:pt>
                <c:pt idx="10">
                  <c:v>37392654-50</c:v>
                </c:pt>
                <c:pt idx="11">
                  <c:v>37392659-55</c:v>
                </c:pt>
                <c:pt idx="12">
                  <c:v>37392664-60</c:v>
                </c:pt>
                <c:pt idx="13">
                  <c:v>37392669-65</c:v>
                </c:pt>
                <c:pt idx="14">
                  <c:v>37392674-70</c:v>
                </c:pt>
                <c:pt idx="15">
                  <c:v>37392679-75</c:v>
                </c:pt>
                <c:pt idx="16">
                  <c:v>37392684-80</c:v>
                </c:pt>
                <c:pt idx="17">
                  <c:v>37392689-85</c:v>
                </c:pt>
                <c:pt idx="18">
                  <c:v>37392695-90</c:v>
                </c:pt>
                <c:pt idx="19">
                  <c:v>37392699-95</c:v>
                </c:pt>
                <c:pt idx="20">
                  <c:v>37392704-00</c:v>
                </c:pt>
                <c:pt idx="21">
                  <c:v>37392709-05</c:v>
                </c:pt>
                <c:pt idx="22">
                  <c:v>37392714-10</c:v>
                </c:pt>
                <c:pt idx="23">
                  <c:v>37392719-15</c:v>
                </c:pt>
                <c:pt idx="24">
                  <c:v>37392724-20</c:v>
                </c:pt>
                <c:pt idx="25">
                  <c:v>37392729-25</c:v>
                </c:pt>
                <c:pt idx="26">
                  <c:v>37392734-30</c:v>
                </c:pt>
                <c:pt idx="27">
                  <c:v>37392739-35</c:v>
                </c:pt>
                <c:pt idx="28">
                  <c:v>37392744-40</c:v>
                </c:pt>
                <c:pt idx="29">
                  <c:v>37392749-45</c:v>
                </c:pt>
                <c:pt idx="30">
                  <c:v>37392754-50</c:v>
                </c:pt>
                <c:pt idx="31">
                  <c:v>37392759-55</c:v>
                </c:pt>
                <c:pt idx="32">
                  <c:v>37392764-60</c:v>
                </c:pt>
              </c:strCache>
            </c:strRef>
          </c:cat>
          <c:val>
            <c:numRef>
              <c:f>'Sheet1 (2)'!$E$2:$E$34</c:f>
              <c:numCache>
                <c:formatCode>General</c:formatCode>
                <c:ptCount val="33"/>
                <c:pt idx="18">
                  <c:v>1</c:v>
                </c:pt>
                <c:pt idx="25">
                  <c:v>0</c:v>
                </c:pt>
                <c:pt idx="26">
                  <c:v>3</c:v>
                </c:pt>
                <c:pt idx="27">
                  <c:v>0</c:v>
                </c:pt>
                <c:pt idx="28">
                  <c:v>3</c:v>
                </c:pt>
                <c:pt idx="29">
                  <c:v>1</c:v>
                </c:pt>
                <c:pt idx="30">
                  <c:v>1</c:v>
                </c:pt>
              </c:numCache>
            </c:numRef>
          </c:val>
        </c:ser>
        <c:ser>
          <c:idx val="4"/>
          <c:order val="4"/>
          <c:tx>
            <c:strRef>
              <c:f>'Sheet1 (2)'!$F$1</c:f>
              <c:strCache>
                <c:ptCount val="1"/>
                <c:pt idx="0">
                  <c:v>Bat Limb 5' RACE</c:v>
                </c:pt>
              </c:strCache>
            </c:strRef>
          </c:tx>
          <c:invertIfNegative val="0"/>
          <c:dPt>
            <c:idx val="31"/>
            <c:invertIfNegative val="0"/>
            <c:bubble3D val="0"/>
            <c:spPr>
              <a:ln w="76200"/>
            </c:spPr>
          </c:dPt>
          <c:cat>
            <c:strRef>
              <c:f>'Sheet1 (2)'!$A$2:$A$34</c:f>
              <c:strCache>
                <c:ptCount val="33"/>
                <c:pt idx="0">
                  <c:v>37392604-00</c:v>
                </c:pt>
                <c:pt idx="1">
                  <c:v>37392609-05</c:v>
                </c:pt>
                <c:pt idx="2">
                  <c:v>37392614-10</c:v>
                </c:pt>
                <c:pt idx="3">
                  <c:v>37392619-15</c:v>
                </c:pt>
                <c:pt idx="4">
                  <c:v>37392624-20</c:v>
                </c:pt>
                <c:pt idx="5">
                  <c:v>37392629-25</c:v>
                </c:pt>
                <c:pt idx="6">
                  <c:v>37392634-30</c:v>
                </c:pt>
                <c:pt idx="7">
                  <c:v>37392639-35</c:v>
                </c:pt>
                <c:pt idx="8">
                  <c:v>37392644-40</c:v>
                </c:pt>
                <c:pt idx="9">
                  <c:v>37392649-45</c:v>
                </c:pt>
                <c:pt idx="10">
                  <c:v>37392654-50</c:v>
                </c:pt>
                <c:pt idx="11">
                  <c:v>37392659-55</c:v>
                </c:pt>
                <c:pt idx="12">
                  <c:v>37392664-60</c:v>
                </c:pt>
                <c:pt idx="13">
                  <c:v>37392669-65</c:v>
                </c:pt>
                <c:pt idx="14">
                  <c:v>37392674-70</c:v>
                </c:pt>
                <c:pt idx="15">
                  <c:v>37392679-75</c:v>
                </c:pt>
                <c:pt idx="16">
                  <c:v>37392684-80</c:v>
                </c:pt>
                <c:pt idx="17">
                  <c:v>37392689-85</c:v>
                </c:pt>
                <c:pt idx="18">
                  <c:v>37392695-90</c:v>
                </c:pt>
                <c:pt idx="19">
                  <c:v>37392699-95</c:v>
                </c:pt>
                <c:pt idx="20">
                  <c:v>37392704-00</c:v>
                </c:pt>
                <c:pt idx="21">
                  <c:v>37392709-05</c:v>
                </c:pt>
                <c:pt idx="22">
                  <c:v>37392714-10</c:v>
                </c:pt>
                <c:pt idx="23">
                  <c:v>37392719-15</c:v>
                </c:pt>
                <c:pt idx="24">
                  <c:v>37392724-20</c:v>
                </c:pt>
                <c:pt idx="25">
                  <c:v>37392729-25</c:v>
                </c:pt>
                <c:pt idx="26">
                  <c:v>37392734-30</c:v>
                </c:pt>
                <c:pt idx="27">
                  <c:v>37392739-35</c:v>
                </c:pt>
                <c:pt idx="28">
                  <c:v>37392744-40</c:v>
                </c:pt>
                <c:pt idx="29">
                  <c:v>37392749-45</c:v>
                </c:pt>
                <c:pt idx="30">
                  <c:v>37392754-50</c:v>
                </c:pt>
                <c:pt idx="31">
                  <c:v>37392759-55</c:v>
                </c:pt>
                <c:pt idx="32">
                  <c:v>37392764-60</c:v>
                </c:pt>
              </c:strCache>
            </c:strRef>
          </c:cat>
          <c:val>
            <c:numRef>
              <c:f>'Sheet1 (2)'!$F$2:$F$34</c:f>
              <c:numCache>
                <c:formatCode>General</c:formatCode>
                <c:ptCount val="33"/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5</c:v>
                </c:pt>
                <c:pt idx="31" formatCode="0">
                  <c:v>1</c:v>
                </c:pt>
              </c:numCache>
            </c:numRef>
          </c:val>
        </c:ser>
        <c:ser>
          <c:idx val="5"/>
          <c:order val="5"/>
          <c:tx>
            <c:strRef>
              <c:f>'Sheet1 (2)'!$G$1</c:f>
              <c:strCache>
                <c:ptCount val="1"/>
                <c:pt idx="0">
                  <c:v>Bat Head 5' RACE</c:v>
                </c:pt>
              </c:strCache>
            </c:strRef>
          </c:tx>
          <c:spPr>
            <a:ln w="76200"/>
          </c:spPr>
          <c:invertIfNegative val="0"/>
          <c:cat>
            <c:strRef>
              <c:f>'Sheet1 (2)'!$A$2:$A$34</c:f>
              <c:strCache>
                <c:ptCount val="33"/>
                <c:pt idx="0">
                  <c:v>37392604-00</c:v>
                </c:pt>
                <c:pt idx="1">
                  <c:v>37392609-05</c:v>
                </c:pt>
                <c:pt idx="2">
                  <c:v>37392614-10</c:v>
                </c:pt>
                <c:pt idx="3">
                  <c:v>37392619-15</c:v>
                </c:pt>
                <c:pt idx="4">
                  <c:v>37392624-20</c:v>
                </c:pt>
                <c:pt idx="5">
                  <c:v>37392629-25</c:v>
                </c:pt>
                <c:pt idx="6">
                  <c:v>37392634-30</c:v>
                </c:pt>
                <c:pt idx="7">
                  <c:v>37392639-35</c:v>
                </c:pt>
                <c:pt idx="8">
                  <c:v>37392644-40</c:v>
                </c:pt>
                <c:pt idx="9">
                  <c:v>37392649-45</c:v>
                </c:pt>
                <c:pt idx="10">
                  <c:v>37392654-50</c:v>
                </c:pt>
                <c:pt idx="11">
                  <c:v>37392659-55</c:v>
                </c:pt>
                <c:pt idx="12">
                  <c:v>37392664-60</c:v>
                </c:pt>
                <c:pt idx="13">
                  <c:v>37392669-65</c:v>
                </c:pt>
                <c:pt idx="14">
                  <c:v>37392674-70</c:v>
                </c:pt>
                <c:pt idx="15">
                  <c:v>37392679-75</c:v>
                </c:pt>
                <c:pt idx="16">
                  <c:v>37392684-80</c:v>
                </c:pt>
                <c:pt idx="17">
                  <c:v>37392689-85</c:v>
                </c:pt>
                <c:pt idx="18">
                  <c:v>37392695-90</c:v>
                </c:pt>
                <c:pt idx="19">
                  <c:v>37392699-95</c:v>
                </c:pt>
                <c:pt idx="20">
                  <c:v>37392704-00</c:v>
                </c:pt>
                <c:pt idx="21">
                  <c:v>37392709-05</c:v>
                </c:pt>
                <c:pt idx="22">
                  <c:v>37392714-10</c:v>
                </c:pt>
                <c:pt idx="23">
                  <c:v>37392719-15</c:v>
                </c:pt>
                <c:pt idx="24">
                  <c:v>37392724-20</c:v>
                </c:pt>
                <c:pt idx="25">
                  <c:v>37392729-25</c:v>
                </c:pt>
                <c:pt idx="26">
                  <c:v>37392734-30</c:v>
                </c:pt>
                <c:pt idx="27">
                  <c:v>37392739-35</c:v>
                </c:pt>
                <c:pt idx="28">
                  <c:v>37392744-40</c:v>
                </c:pt>
                <c:pt idx="29">
                  <c:v>37392749-45</c:v>
                </c:pt>
                <c:pt idx="30">
                  <c:v>37392754-50</c:v>
                </c:pt>
                <c:pt idx="31">
                  <c:v>37392759-55</c:v>
                </c:pt>
                <c:pt idx="32">
                  <c:v>37392764-60</c:v>
                </c:pt>
              </c:strCache>
            </c:strRef>
          </c:cat>
          <c:val>
            <c:numRef>
              <c:f>'Sheet1 (2)'!$G$2:$G$34</c:f>
              <c:numCache>
                <c:formatCode>General</c:formatCode>
                <c:ptCount val="33"/>
                <c:pt idx="24">
                  <c:v>1</c:v>
                </c:pt>
                <c:pt idx="25">
                  <c:v>1</c:v>
                </c:pt>
                <c:pt idx="26">
                  <c:v>4</c:v>
                </c:pt>
                <c:pt idx="28">
                  <c:v>1</c:v>
                </c:pt>
                <c:pt idx="29">
                  <c:v>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2"/>
        <c:axId val="78546432"/>
        <c:axId val="78547968"/>
      </c:barChart>
      <c:catAx>
        <c:axId val="785464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 sz="1200"/>
            </a:pPr>
            <a:endParaRPr lang="en-US"/>
          </a:p>
        </c:txPr>
        <c:crossAx val="78547968"/>
        <c:crosses val="autoZero"/>
        <c:auto val="1"/>
        <c:lblAlgn val="ctr"/>
        <c:lblOffset val="100"/>
        <c:noMultiLvlLbl val="0"/>
      </c:catAx>
      <c:valAx>
        <c:axId val="785479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78546432"/>
        <c:crosses val="autoZero"/>
        <c:crossBetween val="between"/>
      </c:valAx>
      <c:spPr>
        <a:ln w="57150"/>
      </c:spPr>
    </c:plotArea>
    <c:legend>
      <c:legendPos val="r"/>
      <c:layout/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spPr>
    <a:ln w="12700"/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3137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44769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84533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0113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15383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70944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55793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97687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2498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43304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55993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0F1B7-39E5-4230-9B54-CEB6B59C2946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0D853-0CC6-4DA8-8678-D6FB5B1AC85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18225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6890477"/>
              </p:ext>
            </p:extLst>
          </p:nvPr>
        </p:nvGraphicFramePr>
        <p:xfrm>
          <a:off x="476672" y="848544"/>
          <a:ext cx="6205538" cy="3495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2467" y="484026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ZA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33264" y="452095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ZA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264" y="5111080"/>
            <a:ext cx="6334967" cy="39641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88601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2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a Illing</dc:creator>
  <cp:lastModifiedBy>Nicola Illing</cp:lastModifiedBy>
  <cp:revision>3</cp:revision>
  <dcterms:created xsi:type="dcterms:W3CDTF">2014-12-30T12:14:52Z</dcterms:created>
  <dcterms:modified xsi:type="dcterms:W3CDTF">2014-12-30T14:11:17Z</dcterms:modified>
</cp:coreProperties>
</file>